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775" autoAdjust="0"/>
  </p:normalViewPr>
  <p:slideViewPr>
    <p:cSldViewPr snapToGrid="0">
      <p:cViewPr varScale="1">
        <p:scale>
          <a:sx n="66" d="100"/>
          <a:sy n="66" d="100"/>
        </p:scale>
        <p:origin x="5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038413-9EBD-4DA4-B29A-8B2C4F1AD6E1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14CF75-3086-4C69-9951-249B5BA34D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513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14CF75-3086-4C69-9951-249B5BA34DA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9939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81C879-99E4-4D8C-8EBD-FCCC1172FC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3069E9C-335F-4487-B4A5-A9C4D50C64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A2492B-37CD-48C1-9032-74B926A1C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57D789-BA7A-4CC3-A92C-A09A415D0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375CF0-108C-4C03-A6AA-59A000CBD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289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9EEF11-C9C3-410A-BCF4-06F8CAB05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A701F1B-BF3C-4D7D-84FA-09A4102051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03D6B6-BC73-4CBD-823C-391E6C21D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985D79-7360-479E-901B-123D94C10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91C15B-258D-44F3-8512-5A1B7C02D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531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9770D0A-BE97-450E-AF2F-5FD014A72B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AE062C4-7D2B-478A-8E02-FA220C6DFE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D865D4-4944-4D40-A79E-AFC29A984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372DDB-E2B3-4050-9710-100B1DB89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077156-0473-4304-953D-B08893649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991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91DD9A-1B4B-4FCF-9D87-AA361E5D55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39CFE9-C853-49DA-AC05-28D05B49FF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5FC535-9566-40FE-B1D4-983423161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E28528-009E-4B4F-831F-6A71728B2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59FFE1-4781-467A-9616-877C7250A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6577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D902AA-0A7A-46F3-B0E7-3D776464D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FCB4BC-3147-4D0D-AA0B-734D894B1B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B4BF27-83BE-4CC3-9332-B2CC0D255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A8B77A-C9AD-4AE4-B5AD-0FEDF93BA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A37B3F-76C2-455D-BA3E-CF5C1149C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8150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20E7C5-CE41-43FE-9DC7-74AF434D44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52FB867-114A-4675-8D36-626C88F4CF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82093-9FBA-4006-BFFE-8A7D6E576F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327454-D788-4B02-9E7C-BCAB916F7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7FACC1-99F9-4346-AD26-26420BB4D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61CD74-A8ED-4614-8835-9D9F17BD0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1887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3021B8-2055-4232-AE6C-08882CF1C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E4DD1A-F8E0-4355-B2E7-E385F45CFC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EA7D709-013F-4E15-883D-5DB7F1CD43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F132DFE-CEAF-45AD-9B8C-1B0556B6DD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B460F95-38F3-40AC-AC85-E6C95D9388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D9B2981-8393-4707-9DC0-540DD8E4E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5CE8A4D-0F03-42A8-A610-DBBEF85FF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4798ED0-2248-4393-B84F-C5FCD6EA2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5073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B636E0-2753-4A11-A5AE-03BE8E98B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8A5EEA4-50F0-4FB8-8E4D-CF941CB1C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9470868-F2FF-4B81-97FA-CF6666C54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CAB9F42-2A20-43C0-A070-C72D89BF6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669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C4ED5D2-66D7-4401-BE97-0F6362310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6DD7937-97AA-40C7-9C50-34B7E5C69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BD277A-D475-4E3F-B64B-172BB5C65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6601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2676EB-6BFF-4977-96AC-45E354849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5A4C60C-23EB-4F17-985D-BB8A48C2B1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D78862D-4AA8-4481-8C09-3203F50A2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B09936-AB8F-4E72-B98F-C65669DD1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EF81DB-C60C-4C48-9CAC-2524FEF8B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37C37B-A495-4689-A397-18CE53A86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4675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81736B-1C2B-427F-8566-0474BF460E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FB092D9-1BB7-4914-BDF2-0E8ABD5280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89EF628-6B5D-454E-909E-58DECB8704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2CAFED0-5F0A-48C7-A251-A0588F40C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4A08F8-B309-499A-8F20-B7EA4C85E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6C040E-F6A8-42CA-9473-BB5F080DB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2021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FC636D8-38D4-4519-8B18-1593CA5A7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57D9C42-CE43-4FDF-B54F-F0F7756A92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443E92-C466-4994-813A-88578CAB2E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25786-1CA2-4817-A5BB-FF77BC6652CB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5C73CC-350E-42F0-84A2-D1535C41B6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1D4433-C925-4BEB-8227-F9FB4E08E5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E12D1-51E8-485A-96E7-5A2EFE12D7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2592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3" Type="http://schemas.microsoft.com/office/2007/relationships/media" Target="../media/media2.mp4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3.png"/><Relationship Id="rId5" Type="http://schemas.microsoft.com/office/2007/relationships/media" Target="../media/media3.mp4"/><Relationship Id="rId10" Type="http://schemas.openxmlformats.org/officeDocument/2006/relationships/image" Target="../media/image2.png"/><Relationship Id="rId4" Type="http://schemas.openxmlformats.org/officeDocument/2006/relationships/video" Target="../media/media2.mp4"/><Relationship Id="rId9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6-1 merg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8149389" y="1367752"/>
            <a:ext cx="3240000" cy="3240000"/>
          </a:xfrm>
          <a:prstGeom prst="rect">
            <a:avLst/>
          </a:prstGeom>
        </p:spPr>
      </p:pic>
      <p:pic>
        <p:nvPicPr>
          <p:cNvPr id="3" name="6-1 light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4465868" y="1377277"/>
            <a:ext cx="3240000" cy="3240000"/>
          </a:xfrm>
          <a:prstGeom prst="rect">
            <a:avLst/>
          </a:prstGeom>
        </p:spPr>
      </p:pic>
      <p:pic>
        <p:nvPicPr>
          <p:cNvPr id="4" name="6-1 FITC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864393" y="1367752"/>
            <a:ext cx="3240000" cy="3240000"/>
          </a:xfrm>
          <a:prstGeom prst="rect">
            <a:avLst/>
          </a:prstGeom>
        </p:spPr>
      </p:pic>
      <p:pic>
        <p:nvPicPr>
          <p:cNvPr id="5" name="6-1 merg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8105846" y="1367752"/>
            <a:ext cx="3240000" cy="3240000"/>
          </a:xfrm>
          <a:prstGeom prst="rect">
            <a:avLst/>
          </a:prstGeom>
        </p:spPr>
      </p:pic>
      <p:pic>
        <p:nvPicPr>
          <p:cNvPr id="6" name="6-1 light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4465870" y="1367752"/>
            <a:ext cx="3240000" cy="324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828000" y="5273274"/>
            <a:ext cx="1056139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ideos S1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pinach-based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MG in onion cells. Videos were converted from multi-layer scanning images taken under </a:t>
            </a:r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</a:rPr>
              <a:t>fluorescein isothiocyanate (FITC) channel </a:t>
            </a:r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b="1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, and via transmission detector (TD), i.e.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visible light channel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, as well as from the FITC-TD merged images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. Specific S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MG signal are distributed throughout and within onion cells (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, 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. Gold particles on cell surface are visible but generate no specific fluorescence (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, 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. Red and yellow arrows indicate strong or weak green fluorescence in cytosol of different onion cells, respectively. Bars = 100 µm. Videos were produced using the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rogramm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built-in th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nfocal Laser Scanning Microscope. To play video, click Imag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then click the play button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箭头: 下 8">
            <a:extLst>
              <a:ext uri="{FF2B5EF4-FFF2-40B4-BE49-F238E27FC236}">
                <a16:creationId xmlns:a16="http://schemas.microsoft.com/office/drawing/2014/main" id="{E223DCD1-9747-47FC-A64E-A5A44E2D9F70}"/>
              </a:ext>
            </a:extLst>
          </p:cNvPr>
          <p:cNvSpPr/>
          <p:nvPr/>
        </p:nvSpPr>
        <p:spPr>
          <a:xfrm>
            <a:off x="9867371" y="1747367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1" name="箭头: 下 10">
            <a:extLst>
              <a:ext uri="{FF2B5EF4-FFF2-40B4-BE49-F238E27FC236}">
                <a16:creationId xmlns:a16="http://schemas.microsoft.com/office/drawing/2014/main" id="{2B72EDDE-6745-4252-83D6-8DD5FDFC347C}"/>
              </a:ext>
            </a:extLst>
          </p:cNvPr>
          <p:cNvSpPr/>
          <p:nvPr/>
        </p:nvSpPr>
        <p:spPr>
          <a:xfrm>
            <a:off x="9267603" y="1983341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2" name="箭头: 下 11">
            <a:extLst>
              <a:ext uri="{FF2B5EF4-FFF2-40B4-BE49-F238E27FC236}">
                <a16:creationId xmlns:a16="http://schemas.microsoft.com/office/drawing/2014/main" id="{01200F83-4A8F-48EB-B49B-35A53BB04868}"/>
              </a:ext>
            </a:extLst>
          </p:cNvPr>
          <p:cNvSpPr/>
          <p:nvPr/>
        </p:nvSpPr>
        <p:spPr>
          <a:xfrm>
            <a:off x="6285413" y="1747367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3" name="箭头: 下 12">
            <a:extLst>
              <a:ext uri="{FF2B5EF4-FFF2-40B4-BE49-F238E27FC236}">
                <a16:creationId xmlns:a16="http://schemas.microsoft.com/office/drawing/2014/main" id="{0FE54048-9084-499E-BEE2-A2C77A033D75}"/>
              </a:ext>
            </a:extLst>
          </p:cNvPr>
          <p:cNvSpPr/>
          <p:nvPr/>
        </p:nvSpPr>
        <p:spPr>
          <a:xfrm rot="2205258">
            <a:off x="7144352" y="1393097"/>
            <a:ext cx="266299" cy="281979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4" name="箭头: 下 13">
            <a:extLst>
              <a:ext uri="{FF2B5EF4-FFF2-40B4-BE49-F238E27FC236}">
                <a16:creationId xmlns:a16="http://schemas.microsoft.com/office/drawing/2014/main" id="{D8A1BD59-B8F7-46E3-BC88-316938879681}"/>
              </a:ext>
            </a:extLst>
          </p:cNvPr>
          <p:cNvSpPr/>
          <p:nvPr/>
        </p:nvSpPr>
        <p:spPr>
          <a:xfrm>
            <a:off x="5685645" y="1983341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id="{E354DC32-0911-4AE4-94EB-56DA215FB11F}"/>
              </a:ext>
            </a:extLst>
          </p:cNvPr>
          <p:cNvSpPr/>
          <p:nvPr/>
        </p:nvSpPr>
        <p:spPr>
          <a:xfrm rot="2205258">
            <a:off x="4564765" y="3664660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6" name="箭头: 下 15">
            <a:extLst>
              <a:ext uri="{FF2B5EF4-FFF2-40B4-BE49-F238E27FC236}">
                <a16:creationId xmlns:a16="http://schemas.microsoft.com/office/drawing/2014/main" id="{F327F964-9ED5-4FEC-88B1-E6A669F0B423}"/>
              </a:ext>
            </a:extLst>
          </p:cNvPr>
          <p:cNvSpPr/>
          <p:nvPr/>
        </p:nvSpPr>
        <p:spPr>
          <a:xfrm>
            <a:off x="2666305" y="1747367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7" name="箭头: 下 16">
            <a:extLst>
              <a:ext uri="{FF2B5EF4-FFF2-40B4-BE49-F238E27FC236}">
                <a16:creationId xmlns:a16="http://schemas.microsoft.com/office/drawing/2014/main" id="{38912A67-E58D-4A1B-B72F-27C8CAAE6109}"/>
              </a:ext>
            </a:extLst>
          </p:cNvPr>
          <p:cNvSpPr/>
          <p:nvPr/>
        </p:nvSpPr>
        <p:spPr>
          <a:xfrm>
            <a:off x="2066537" y="1983341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8" name="箭头: 下 17">
            <a:extLst>
              <a:ext uri="{FF2B5EF4-FFF2-40B4-BE49-F238E27FC236}">
                <a16:creationId xmlns:a16="http://schemas.microsoft.com/office/drawing/2014/main" id="{64C3620B-7477-4A14-A1E0-BBC7C8F5028D}"/>
              </a:ext>
            </a:extLst>
          </p:cNvPr>
          <p:cNvSpPr/>
          <p:nvPr/>
        </p:nvSpPr>
        <p:spPr>
          <a:xfrm rot="2205258">
            <a:off x="945657" y="3664660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DDC42C2-C3A0-41E1-8261-C6EBAAA26C4F}"/>
              </a:ext>
            </a:extLst>
          </p:cNvPr>
          <p:cNvSpPr txBox="1"/>
          <p:nvPr/>
        </p:nvSpPr>
        <p:spPr>
          <a:xfrm>
            <a:off x="9442405" y="4307303"/>
            <a:ext cx="641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8220ADD-F5F6-4A70-957E-9526B0314900}"/>
              </a:ext>
            </a:extLst>
          </p:cNvPr>
          <p:cNvSpPr txBox="1"/>
          <p:nvPr/>
        </p:nvSpPr>
        <p:spPr>
          <a:xfrm>
            <a:off x="2204191" y="4307303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TC</a:t>
            </a:r>
            <a:endParaRPr lang="zh-CN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999149D-63B4-4CE8-BB40-DA4FA03C7818}"/>
              </a:ext>
            </a:extLst>
          </p:cNvPr>
          <p:cNvSpPr txBox="1"/>
          <p:nvPr/>
        </p:nvSpPr>
        <p:spPr>
          <a:xfrm>
            <a:off x="5919550" y="4307303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endParaRPr lang="zh-CN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0BF0DC5-00D4-48C6-B5D2-4E6EBF3830E7}"/>
              </a:ext>
            </a:extLst>
          </p:cNvPr>
          <p:cNvSpPr txBox="1"/>
          <p:nvPr/>
        </p:nvSpPr>
        <p:spPr>
          <a:xfrm>
            <a:off x="738739" y="448057"/>
            <a:ext cx="4683866" cy="4218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INFORMATION - VIDEO </a:t>
            </a:r>
            <a:endParaRPr lang="zh-CN" altLang="zh-CN" sz="1600" dirty="0">
              <a:effectLst/>
              <a:latin typeface="Calibri" panose="020F050202020403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2" name="箭头: 下 21">
            <a:extLst>
              <a:ext uri="{FF2B5EF4-FFF2-40B4-BE49-F238E27FC236}">
                <a16:creationId xmlns:a16="http://schemas.microsoft.com/office/drawing/2014/main" id="{DF416CE6-E723-4F42-87E3-735961C2671D}"/>
              </a:ext>
            </a:extLst>
          </p:cNvPr>
          <p:cNvSpPr/>
          <p:nvPr/>
        </p:nvSpPr>
        <p:spPr>
          <a:xfrm rot="2205258">
            <a:off x="8212753" y="3664660"/>
            <a:ext cx="266299" cy="28197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24" name="箭头: 下 23">
            <a:extLst>
              <a:ext uri="{FF2B5EF4-FFF2-40B4-BE49-F238E27FC236}">
                <a16:creationId xmlns:a16="http://schemas.microsoft.com/office/drawing/2014/main" id="{655CDCF7-4B6D-409D-835C-C897AEF05ADE}"/>
              </a:ext>
            </a:extLst>
          </p:cNvPr>
          <p:cNvSpPr/>
          <p:nvPr/>
        </p:nvSpPr>
        <p:spPr>
          <a:xfrm rot="2205258">
            <a:off x="3659985" y="1393097"/>
            <a:ext cx="266299" cy="281979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>
              <a:solidFill>
                <a:srgbClr val="FFFF00"/>
              </a:solidFill>
            </a:endParaRPr>
          </a:p>
        </p:txBody>
      </p:sp>
      <p:sp>
        <p:nvSpPr>
          <p:cNvPr id="25" name="箭头: 下 24">
            <a:extLst>
              <a:ext uri="{FF2B5EF4-FFF2-40B4-BE49-F238E27FC236}">
                <a16:creationId xmlns:a16="http://schemas.microsoft.com/office/drawing/2014/main" id="{0BE2F79C-1A91-47B9-9A7C-55C9BEEA2E1A}"/>
              </a:ext>
            </a:extLst>
          </p:cNvPr>
          <p:cNvSpPr/>
          <p:nvPr/>
        </p:nvSpPr>
        <p:spPr>
          <a:xfrm rot="2205258">
            <a:off x="10282189" y="1393097"/>
            <a:ext cx="266299" cy="281979"/>
          </a:xfrm>
          <a:prstGeom prst="downArrow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i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5006B59-2534-47B9-AC9A-916F17F5101D}"/>
              </a:ext>
            </a:extLst>
          </p:cNvPr>
          <p:cNvSpPr txBox="1"/>
          <p:nvPr/>
        </p:nvSpPr>
        <p:spPr>
          <a:xfrm>
            <a:off x="828000" y="1321357"/>
            <a:ext cx="389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51E52F8-9274-4D71-BAC9-000EC6BEB820}"/>
              </a:ext>
            </a:extLst>
          </p:cNvPr>
          <p:cNvSpPr txBox="1"/>
          <p:nvPr/>
        </p:nvSpPr>
        <p:spPr>
          <a:xfrm>
            <a:off x="4428000" y="1321357"/>
            <a:ext cx="389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1413696-3896-44C3-968C-A9CE205E0F3A}"/>
              </a:ext>
            </a:extLst>
          </p:cNvPr>
          <p:cNvSpPr txBox="1"/>
          <p:nvPr/>
        </p:nvSpPr>
        <p:spPr>
          <a:xfrm>
            <a:off x="8064000" y="1321357"/>
            <a:ext cx="389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530872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seq concurrent="1" nextAc="seek">
              <p:cTn id="25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6" fill="hold">
                      <p:stCondLst>
                        <p:cond delay="0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9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30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3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</TotalTime>
  <Words>154</Words>
  <Application>Microsoft Office PowerPoint</Application>
  <PresentationFormat>宽屏</PresentationFormat>
  <Paragraphs>9</Paragraphs>
  <Slides>1</Slides>
  <Notes>1</Notes>
  <HiddenSlides>0</HiddenSlides>
  <MMClips>5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ong, Yiguo</dc:creator>
  <cp:lastModifiedBy>Hong, Yiguo</cp:lastModifiedBy>
  <cp:revision>40</cp:revision>
  <dcterms:created xsi:type="dcterms:W3CDTF">2021-05-25T18:55:15Z</dcterms:created>
  <dcterms:modified xsi:type="dcterms:W3CDTF">2021-09-10T14:39:38Z</dcterms:modified>
</cp:coreProperties>
</file>